
<file path=[Content_Types].xml><?xml version="1.0" encoding="utf-8"?>
<Types xmlns="http://schemas.openxmlformats.org/package/2006/content-types"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3150" y="-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5BD377FB-A247-476D-AE93-F8B41C00A519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1E4F597-A026-4308-921B-2D4B46BF857E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620076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B2037-2EE8-47C3-8842-06C9088B032E}" type="datetimeFigureOut">
              <a:rPr lang="de-DE" smtClean="0"/>
              <a:pPr/>
              <a:t>09.1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FECD5-BCBB-4642-9085-B4FBCB2AA62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wm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>
            <a:grpSpLocks noChangeAspect="1"/>
          </p:cNvGrpSpPr>
          <p:nvPr/>
        </p:nvGrpSpPr>
        <p:grpSpPr>
          <a:xfrm>
            <a:off x="520687" y="665828"/>
            <a:ext cx="5906617" cy="5871348"/>
            <a:chOff x="3247863" y="1034074"/>
            <a:chExt cx="5716625" cy="5682490"/>
          </a:xfrm>
        </p:grpSpPr>
        <p:pic>
          <p:nvPicPr>
            <p:cNvPr id="3" name="Picture 2" descr="X:\sfb\Anke\Arabidopsis\Developmental Trajectory (Morphometry and  Metabolites) Versuch 1\4_Bilder_sfb\Metabolite Versuch 1 LM\d10\02_x20m_OT1_18032013_AB_AraMet1_d10 Tetraden und Gyn open_BA.tif"/>
            <p:cNvPicPr>
              <a:picLocks noChangeAspect="1" noChangeArrowheads="1"/>
            </p:cNvPicPr>
            <p:nvPr/>
          </p:nvPicPr>
          <p:blipFill>
            <a:blip r:embed="rId2" cstate="print"/>
            <a:srcRect l="15100" r="4783" b="10676"/>
            <a:stretch>
              <a:fillRect/>
            </a:stretch>
          </p:blipFill>
          <p:spPr bwMode="auto">
            <a:xfrm>
              <a:off x="3282630" y="1124744"/>
              <a:ext cx="1514725" cy="2664296"/>
            </a:xfrm>
            <a:prstGeom prst="rect">
              <a:avLst/>
            </a:prstGeom>
            <a:noFill/>
            <a:ln w="3175"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4" name="Textfeld 3"/>
            <p:cNvSpPr txBox="1"/>
            <p:nvPr/>
          </p:nvSpPr>
          <p:spPr>
            <a:xfrm>
              <a:off x="3247863" y="1112547"/>
              <a:ext cx="327664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de-AT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8028384" y="1124744"/>
              <a:ext cx="352487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876256" y="1124744"/>
              <a:ext cx="315253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904047" y="1124744"/>
              <a:ext cx="340076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885385" y="2852936"/>
              <a:ext cx="340076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901609" y="2852936"/>
              <a:ext cx="327664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275856" y="3861048"/>
              <a:ext cx="327664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B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" name="Gruppieren 40"/>
            <p:cNvGrpSpPr/>
            <p:nvPr/>
          </p:nvGrpSpPr>
          <p:grpSpPr>
            <a:xfrm>
              <a:off x="4886291" y="1034074"/>
              <a:ext cx="1944216" cy="1765043"/>
              <a:chOff x="4886291" y="1034074"/>
              <a:chExt cx="1944216" cy="1765043"/>
            </a:xfrm>
          </p:grpSpPr>
          <p:pic>
            <p:nvPicPr>
              <p:cNvPr id="68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t="-5345" b="1147"/>
              <a:stretch>
                <a:fillRect/>
              </a:stretch>
            </p:blipFill>
            <p:spPr bwMode="auto">
              <a:xfrm>
                <a:off x="4886291" y="1034074"/>
                <a:ext cx="1944216" cy="17650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69" name="Gerade Verbindung 68"/>
              <p:cNvCxnSpPr/>
              <p:nvPr/>
            </p:nvCxnSpPr>
            <p:spPr>
              <a:xfrm flipH="1">
                <a:off x="6433615" y="2705678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uppieren 50"/>
            <p:cNvGrpSpPr/>
            <p:nvPr/>
          </p:nvGrpSpPr>
          <p:grpSpPr>
            <a:xfrm>
              <a:off x="6900760" y="1124744"/>
              <a:ext cx="1039229" cy="1674846"/>
              <a:chOff x="6900760" y="1124744"/>
              <a:chExt cx="1039229" cy="1674846"/>
            </a:xfrm>
          </p:grpSpPr>
          <p:pic>
            <p:nvPicPr>
              <p:cNvPr id="66" name="Picture 6" descr="C:\Program Files\Xradia\MicroXCT\7.0.2817\3DViewer\share\examine_report/resources/genmacrep-page-5_0.bmp"/>
              <p:cNvPicPr>
                <a:picLocks noChangeAspect="1"/>
              </p:cNvPicPr>
              <p:nvPr/>
            </p:nvPicPr>
            <p:blipFill>
              <a:blip r:embed="rId4" cstate="print"/>
              <a:srcRect l="28734" t="16721" r="31798" b="13757"/>
              <a:stretch>
                <a:fillRect/>
              </a:stretch>
            </p:blipFill>
            <p:spPr bwMode="auto">
              <a:xfrm>
                <a:off x="6900760" y="1124744"/>
                <a:ext cx="1039229" cy="16748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67" name="Gerade Verbindung 66"/>
              <p:cNvCxnSpPr/>
              <p:nvPr/>
            </p:nvCxnSpPr>
            <p:spPr>
              <a:xfrm flipH="1">
                <a:off x="7740352" y="2705962"/>
                <a:ext cx="129281" cy="602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pieren 58"/>
            <p:cNvGrpSpPr/>
            <p:nvPr/>
          </p:nvGrpSpPr>
          <p:grpSpPr>
            <a:xfrm>
              <a:off x="8011284" y="1124744"/>
              <a:ext cx="953204" cy="5583394"/>
              <a:chOff x="8011284" y="1124744"/>
              <a:chExt cx="953204" cy="5583394"/>
            </a:xfrm>
          </p:grpSpPr>
          <p:pic>
            <p:nvPicPr>
              <p:cNvPr id="64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44927" t="12933" r="44204" b="10942"/>
              <a:stretch>
                <a:fillRect/>
              </a:stretch>
            </p:blipFill>
            <p:spPr bwMode="auto">
              <a:xfrm>
                <a:off x="8011284" y="1124744"/>
                <a:ext cx="953204" cy="55833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65" name="Gerade Verbindung 64"/>
              <p:cNvCxnSpPr/>
              <p:nvPr/>
            </p:nvCxnSpPr>
            <p:spPr>
              <a:xfrm flipH="1">
                <a:off x="8772009" y="6593769"/>
                <a:ext cx="73816" cy="1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uppieren 66"/>
            <p:cNvGrpSpPr/>
            <p:nvPr/>
          </p:nvGrpSpPr>
          <p:grpSpPr>
            <a:xfrm>
              <a:off x="4897632" y="2852936"/>
              <a:ext cx="1921752" cy="3857652"/>
              <a:chOff x="4897632" y="2852936"/>
              <a:chExt cx="1921752" cy="3857652"/>
            </a:xfrm>
          </p:grpSpPr>
          <p:pic>
            <p:nvPicPr>
              <p:cNvPr id="62" name="Picture 3" descr="C:\Program Files\Xradia\MicroXCT\7.0.2817\3DViewer\share\examine_report/resources/genmacrep-page-2_0.bmp"/>
              <p:cNvPicPr>
                <a:picLocks noChangeAspect="1"/>
              </p:cNvPicPr>
              <p:nvPr/>
            </p:nvPicPr>
            <p:blipFill>
              <a:blip r:embed="rId6" cstate="print">
                <a:lum contrast="-10000"/>
              </a:blip>
              <a:srcRect l="26353" t="9590" r="33239" b="1315"/>
              <a:stretch>
                <a:fillRect/>
              </a:stretch>
            </p:blipFill>
            <p:spPr bwMode="auto">
              <a:xfrm>
                <a:off x="4897632" y="2852936"/>
                <a:ext cx="1921752" cy="38576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63" name="Gerade Verbindung 62"/>
              <p:cNvCxnSpPr/>
              <p:nvPr/>
            </p:nvCxnSpPr>
            <p:spPr>
              <a:xfrm flipH="1">
                <a:off x="6568172" y="6602603"/>
                <a:ext cx="164068" cy="403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uppieren 69"/>
            <p:cNvGrpSpPr/>
            <p:nvPr/>
          </p:nvGrpSpPr>
          <p:grpSpPr>
            <a:xfrm>
              <a:off x="6904249" y="2852936"/>
              <a:ext cx="1033465" cy="3863628"/>
              <a:chOff x="6904249" y="2852936"/>
              <a:chExt cx="1033465" cy="3863628"/>
            </a:xfrm>
          </p:grpSpPr>
          <p:pic>
            <p:nvPicPr>
              <p:cNvPr id="60" name="Picture 3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37423" t="12174" r="41093" b="-59"/>
              <a:stretch>
                <a:fillRect/>
              </a:stretch>
            </p:blipFill>
            <p:spPr bwMode="auto">
              <a:xfrm>
                <a:off x="6904249" y="2852936"/>
                <a:ext cx="1033465" cy="38636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61" name="Gerade Verbindung 60"/>
              <p:cNvCxnSpPr/>
              <p:nvPr/>
            </p:nvCxnSpPr>
            <p:spPr>
              <a:xfrm flipH="1">
                <a:off x="7668344" y="6596796"/>
                <a:ext cx="154535" cy="556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uppieren 67"/>
            <p:cNvGrpSpPr/>
            <p:nvPr/>
          </p:nvGrpSpPr>
          <p:grpSpPr>
            <a:xfrm>
              <a:off x="3275856" y="3861049"/>
              <a:ext cx="1528190" cy="2852325"/>
              <a:chOff x="3275856" y="3861049"/>
              <a:chExt cx="1528190" cy="2852325"/>
            </a:xfrm>
          </p:grpSpPr>
          <p:pic>
            <p:nvPicPr>
              <p:cNvPr id="58" name="Picture 29" descr="C:\Program Files\Xradia\MicroXCT\7.0.2817\3DViewer\share\examine_report/resources/genmacrep-page-28_0.bmp"/>
              <p:cNvPicPr/>
              <p:nvPr/>
            </p:nvPicPr>
            <p:blipFill>
              <a:blip r:embed="rId8" cstate="print"/>
              <a:srcRect l="14067" t="25332" r="37865" b="43873"/>
              <a:stretch>
                <a:fillRect/>
              </a:stretch>
            </p:blipFill>
            <p:spPr bwMode="auto">
              <a:xfrm rot="5400000">
                <a:off x="2613788" y="4523117"/>
                <a:ext cx="2852325" cy="15281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59" name="Gerade Verbindung 58"/>
              <p:cNvCxnSpPr/>
              <p:nvPr/>
            </p:nvCxnSpPr>
            <p:spPr>
              <a:xfrm flipH="1">
                <a:off x="4188998" y="6617211"/>
                <a:ext cx="530121" cy="403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" name="Gerade Verbindung 16"/>
            <p:cNvCxnSpPr/>
            <p:nvPr/>
          </p:nvCxnSpPr>
          <p:spPr>
            <a:xfrm flipH="1">
              <a:off x="4202629" y="3724211"/>
              <a:ext cx="576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feld 17"/>
            <p:cNvSpPr txBox="1"/>
            <p:nvPr/>
          </p:nvSpPr>
          <p:spPr>
            <a:xfrm>
              <a:off x="4888667" y="1124744"/>
              <a:ext cx="340076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6914708" y="1124744"/>
              <a:ext cx="315253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8019432" y="1116355"/>
              <a:ext cx="352487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4886783" y="2852936"/>
              <a:ext cx="340076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6926590" y="2852936"/>
              <a:ext cx="327664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275856" y="3861048"/>
              <a:ext cx="327664" cy="3574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B</a:t>
              </a:r>
              <a:endParaRPr lang="de-AT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4180949" y="1799123"/>
              <a:ext cx="471068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 err="1" smtClean="0">
                  <a:latin typeface="Arial" pitchFamily="34" charset="0"/>
                  <a:cs typeface="Arial" pitchFamily="34" charset="0"/>
                </a:rPr>
                <a:t>Tds</a:t>
              </a:r>
              <a:endParaRPr lang="de-AT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5" name="Gerade Verbindung mit Pfeil 24"/>
            <p:cNvCxnSpPr/>
            <p:nvPr/>
          </p:nvCxnSpPr>
          <p:spPr>
            <a:xfrm>
              <a:off x="4498328" y="1993479"/>
              <a:ext cx="95340" cy="182013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25"/>
            <p:cNvSpPr txBox="1"/>
            <p:nvPr/>
          </p:nvSpPr>
          <p:spPr>
            <a:xfrm>
              <a:off x="4113950" y="2143188"/>
              <a:ext cx="360040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 smtClean="0">
                  <a:latin typeface="Arial" pitchFamily="34" charset="0"/>
                  <a:cs typeface="Arial" pitchFamily="34" charset="0"/>
                </a:rPr>
                <a:t>T</a:t>
              </a:r>
              <a:endParaRPr lang="de-AT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Gerade Verbindung mit Pfeil 26"/>
            <p:cNvCxnSpPr/>
            <p:nvPr/>
          </p:nvCxnSpPr>
          <p:spPr>
            <a:xfrm>
              <a:off x="4249363" y="2311521"/>
              <a:ext cx="95340" cy="182013"/>
            </a:xfrm>
            <a:prstGeom prst="straightConnector1">
              <a:avLst/>
            </a:prstGeom>
            <a:ln w="6350">
              <a:solidFill>
                <a:schemeClr val="tx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/>
            <p:cNvSpPr txBox="1"/>
            <p:nvPr/>
          </p:nvSpPr>
          <p:spPr>
            <a:xfrm>
              <a:off x="3995936" y="4797732"/>
              <a:ext cx="360040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T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9" name="Gerade Verbindung mit Pfeil 28"/>
            <p:cNvCxnSpPr/>
            <p:nvPr/>
          </p:nvCxnSpPr>
          <p:spPr>
            <a:xfrm>
              <a:off x="4131349" y="4975179"/>
              <a:ext cx="95340" cy="182013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feld 29"/>
            <p:cNvSpPr txBox="1"/>
            <p:nvPr/>
          </p:nvSpPr>
          <p:spPr>
            <a:xfrm>
              <a:off x="5993110" y="1398498"/>
              <a:ext cx="302841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S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6209159" y="1265684"/>
              <a:ext cx="254747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5292080" y="1916832"/>
              <a:ext cx="260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6516216" y="1196752"/>
              <a:ext cx="2487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6002635" y="1246098"/>
              <a:ext cx="274915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5724128" y="2564904"/>
              <a:ext cx="547574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G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6" name="Gerade Verbindung mit Pfeil 35"/>
            <p:cNvCxnSpPr/>
            <p:nvPr/>
          </p:nvCxnSpPr>
          <p:spPr>
            <a:xfrm flipH="1">
              <a:off x="5604772" y="2685059"/>
              <a:ext cx="190279" cy="21142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feld 36"/>
            <p:cNvSpPr txBox="1"/>
            <p:nvPr/>
          </p:nvSpPr>
          <p:spPr>
            <a:xfrm>
              <a:off x="3635896" y="1700808"/>
              <a:ext cx="2487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4283968" y="2636912"/>
              <a:ext cx="260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de-AT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3815952" y="3069540"/>
              <a:ext cx="274915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4211960" y="5445224"/>
              <a:ext cx="260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5648535" y="2853516"/>
              <a:ext cx="451030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G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3" name="Gerade Verbindung mit Pfeil 42"/>
            <p:cNvCxnSpPr/>
            <p:nvPr/>
          </p:nvCxnSpPr>
          <p:spPr>
            <a:xfrm flipV="1">
              <a:off x="5943600" y="2951019"/>
              <a:ext cx="261257" cy="5937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6172770" y="2910194"/>
              <a:ext cx="531834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P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6083416" y="3141548"/>
              <a:ext cx="301686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t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6102019" y="4028514"/>
              <a:ext cx="274915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5909698" y="3984172"/>
              <a:ext cx="251992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5183692" y="4469100"/>
              <a:ext cx="251992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5292080" y="3573016"/>
              <a:ext cx="251992" cy="238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5863255" y="4526893"/>
              <a:ext cx="302841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S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7668344" y="2132856"/>
              <a:ext cx="302841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S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2" name="Gerade Verbindung mit Pfeil 51"/>
            <p:cNvCxnSpPr/>
            <p:nvPr/>
          </p:nvCxnSpPr>
          <p:spPr>
            <a:xfrm flipH="1" flipV="1">
              <a:off x="7616190" y="2095500"/>
              <a:ext cx="110491" cy="144780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feld 52"/>
            <p:cNvSpPr txBox="1"/>
            <p:nvPr/>
          </p:nvSpPr>
          <p:spPr>
            <a:xfrm>
              <a:off x="7156668" y="1704618"/>
              <a:ext cx="260953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7994966" y="3107748"/>
              <a:ext cx="260953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5" name="Gerade Verbindung mit Pfeil 54"/>
            <p:cNvCxnSpPr/>
            <p:nvPr/>
          </p:nvCxnSpPr>
          <p:spPr>
            <a:xfrm>
              <a:off x="8154135" y="3216375"/>
              <a:ext cx="148590" cy="19050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feld 55"/>
            <p:cNvSpPr txBox="1"/>
            <p:nvPr/>
          </p:nvSpPr>
          <p:spPr>
            <a:xfrm>
              <a:off x="7975017" y="2391076"/>
              <a:ext cx="260953" cy="238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</a:t>
              </a:r>
              <a:endParaRPr lang="de-AT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7" name="Gerade Verbindung mit Pfeil 56"/>
            <p:cNvCxnSpPr/>
            <p:nvPr/>
          </p:nvCxnSpPr>
          <p:spPr>
            <a:xfrm>
              <a:off x="8171376" y="2521937"/>
              <a:ext cx="114480" cy="24552"/>
            </a:xfrm>
            <a:prstGeom prst="straightConnector1">
              <a:avLst/>
            </a:prstGeom>
            <a:ln w="6350">
              <a:solidFill>
                <a:schemeClr val="bg1"/>
              </a:solidFill>
              <a:headEnd w="med" len="sm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Textfeld 70"/>
          <p:cNvSpPr txBox="1"/>
          <p:nvPr/>
        </p:nvSpPr>
        <p:spPr>
          <a:xfrm>
            <a:off x="908720" y="5066819"/>
            <a:ext cx="257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G</a:t>
            </a:r>
            <a:endParaRPr lang="de-AT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207217" y="128464"/>
            <a:ext cx="4086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 smtClean="0"/>
              <a:t>Supporting</a:t>
            </a:r>
            <a:r>
              <a:rPr lang="de-AT" dirty="0" smtClean="0"/>
              <a:t> Information </a:t>
            </a:r>
            <a:r>
              <a:rPr lang="de-AT" dirty="0" err="1" smtClean="0"/>
              <a:t>Figures</a:t>
            </a:r>
            <a:r>
              <a:rPr lang="de-AT" dirty="0" smtClean="0"/>
              <a:t> S1 </a:t>
            </a:r>
            <a:r>
              <a:rPr lang="de-AT" dirty="0" err="1" smtClean="0"/>
              <a:t>and</a:t>
            </a:r>
            <a:r>
              <a:rPr lang="de-AT" dirty="0" smtClean="0"/>
              <a:t> S2</a:t>
            </a:r>
            <a:endParaRPr lang="de-AT" dirty="0"/>
          </a:p>
        </p:txBody>
      </p:sp>
      <p:sp>
        <p:nvSpPr>
          <p:cNvPr id="41" name="Textfeld 40"/>
          <p:cNvSpPr txBox="1"/>
          <p:nvPr/>
        </p:nvSpPr>
        <p:spPr>
          <a:xfrm>
            <a:off x="359945" y="6679445"/>
            <a:ext cx="5906617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Figure S1</a:t>
            </a:r>
          </a:p>
          <a:p>
            <a:r>
              <a:rPr lang="en-US" sz="1000" dirty="0"/>
              <a:t>Different phases during Arabidopsis thaliana pAP1::AP1-GR ap1-1 cal-5 flower development. A-B Day 10, longitudinal sections of gynoecium and anther of a </a:t>
            </a:r>
            <a:r>
              <a:rPr lang="en-US" sz="1000" dirty="0" err="1"/>
              <a:t>preanthetic</a:t>
            </a:r>
            <a:r>
              <a:rPr lang="en-US" sz="1000" dirty="0"/>
              <a:t> flower. A Light microscopy bright-field photograph of microtome section stained with ruthenium red and </a:t>
            </a:r>
            <a:r>
              <a:rPr lang="en-US" sz="1000" dirty="0" err="1"/>
              <a:t>toluidin</a:t>
            </a:r>
            <a:r>
              <a:rPr lang="en-US" sz="1000" dirty="0"/>
              <a:t> blue. The carpels form an open ended tube. Ovules arise. The microspores are associated in tetrads. The </a:t>
            </a:r>
            <a:r>
              <a:rPr lang="en-US" sz="1000" dirty="0" err="1"/>
              <a:t>tapetum</a:t>
            </a:r>
            <a:r>
              <a:rPr lang="en-US" sz="1000" dirty="0"/>
              <a:t> is metabolically highly active, indicated by the dark blue staining. B Micro-CT virtual section. The cells of the </a:t>
            </a:r>
            <a:r>
              <a:rPr lang="en-US" sz="1000" dirty="0" err="1"/>
              <a:t>tapetum</a:t>
            </a:r>
            <a:r>
              <a:rPr lang="en-US" sz="1000" dirty="0"/>
              <a:t> show a high contrast and can be seen as a bright line on the inner side of the pollen sac. C-E Day 18, </a:t>
            </a:r>
            <a:r>
              <a:rPr lang="en-US" sz="1000" dirty="0" err="1"/>
              <a:t>anthetic</a:t>
            </a:r>
            <a:r>
              <a:rPr lang="en-US" sz="1000" dirty="0"/>
              <a:t> flower. C Micro-CT virtual cross section of gynoecium and anther. The ovules are located on parietal placentae in the two </a:t>
            </a:r>
            <a:r>
              <a:rPr lang="en-US" sz="1000" dirty="0" err="1"/>
              <a:t>locules</a:t>
            </a:r>
            <a:r>
              <a:rPr lang="en-US" sz="1000" dirty="0"/>
              <a:t>, which are divided by a false septum. </a:t>
            </a:r>
            <a:r>
              <a:rPr lang="en-US" sz="1000" dirty="0" err="1"/>
              <a:t>Tapetum</a:t>
            </a:r>
            <a:r>
              <a:rPr lang="en-US" sz="1000" dirty="0"/>
              <a:t> has dissolved as there is no bright line on the inner side of the pollen sac in the micro-CT visible (compare with B). The dehisced anther releases mature pollen, highly contrasted in the picture. D Micro-CT virtual longitudinal section of gynoecium in the </a:t>
            </a:r>
            <a:r>
              <a:rPr lang="en-US" sz="1000" dirty="0" err="1"/>
              <a:t>dorsiventral</a:t>
            </a:r>
            <a:r>
              <a:rPr lang="en-US" sz="1000" dirty="0"/>
              <a:t> plane and stamen. Pollination by a pollen grain on the receptive stigmatic papillae, connected by a short style to the long ovary containing many ovules. Dehisced empty anther on an elongated filament (on the left hand side in the picture).E Micro-CT virtual longitudinal section of gynoecium in the plane of the false septum, which is visible throughout the whole </a:t>
            </a:r>
            <a:r>
              <a:rPr lang="en-US" sz="1000" dirty="0" err="1"/>
              <a:t>silique</a:t>
            </a:r>
            <a:r>
              <a:rPr lang="en-US" sz="1000" dirty="0"/>
              <a:t>. F-G Day 27 fruit. F Micro-CT virtual cross section of fruit and three seeds. The false septum has reduced its thickness. G Micro-CT virtual longitudinal section of the </a:t>
            </a:r>
            <a:r>
              <a:rPr lang="en-US" sz="1000" dirty="0" err="1"/>
              <a:t>silique</a:t>
            </a:r>
            <a:r>
              <a:rPr lang="en-US" sz="1000" dirty="0"/>
              <a:t> after fertilization, containing the seeds with the dicotyledonous embryos inside. Stigmatic papillae and androecium had fallen off. A, anther; E, embryo; F, filament; </a:t>
            </a:r>
            <a:r>
              <a:rPr lang="en-US" sz="1000" dirty="0" err="1"/>
              <a:t>fS</a:t>
            </a:r>
            <a:r>
              <a:rPr lang="en-US" sz="1000" dirty="0"/>
              <a:t>, false septum; G, gynoecium; L, </a:t>
            </a:r>
            <a:r>
              <a:rPr lang="en-US" sz="1000" dirty="0" err="1"/>
              <a:t>locule</a:t>
            </a:r>
            <a:r>
              <a:rPr lang="en-US" sz="1000" dirty="0"/>
              <a:t>; O, ovule; PG, pollen grain; </a:t>
            </a:r>
            <a:r>
              <a:rPr lang="en-US" sz="1000" dirty="0" err="1"/>
              <a:t>sP</a:t>
            </a:r>
            <a:r>
              <a:rPr lang="en-US" sz="1000" dirty="0"/>
              <a:t>, stigmatic papillae; S, seed; St, style;  T, </a:t>
            </a:r>
            <a:r>
              <a:rPr lang="en-US" sz="1000" dirty="0" err="1"/>
              <a:t>tapetum</a:t>
            </a:r>
            <a:r>
              <a:rPr lang="en-US" sz="1000" dirty="0"/>
              <a:t>; </a:t>
            </a:r>
            <a:r>
              <a:rPr lang="en-US" sz="1000" dirty="0" err="1"/>
              <a:t>Tds</a:t>
            </a:r>
            <a:r>
              <a:rPr lang="en-US" sz="1000" dirty="0"/>
              <a:t>, tetrads; Bars = 100 µm</a:t>
            </a:r>
          </a:p>
          <a:p>
            <a:endParaRPr lang="de-AT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514350" y="1640632"/>
            <a:ext cx="7521263" cy="5314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hteck 1"/>
          <p:cNvSpPr/>
          <p:nvPr/>
        </p:nvSpPr>
        <p:spPr>
          <a:xfrm>
            <a:off x="404664" y="7113240"/>
            <a:ext cx="576064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S2</a:t>
            </a:r>
            <a:endParaRPr lang="de-AT" b="1" dirty="0"/>
          </a:p>
          <a:p>
            <a:r>
              <a:rPr lang="en-US" dirty="0"/>
              <a:t>PCA loadings of the combined morphometric and metabolic covariance matrix of Figure 6.</a:t>
            </a:r>
            <a:endParaRPr lang="de-AT" dirty="0"/>
          </a:p>
        </p:txBody>
      </p:sp>
    </p:spTree>
    <p:extLst>
      <p:ext uri="{BB962C8B-B14F-4D97-AF65-F5344CB8AC3E}">
        <p14:creationId xmlns:p14="http://schemas.microsoft.com/office/powerpoint/2010/main" val="25813147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5</Words>
  <Application>Microsoft Office PowerPoint</Application>
  <PresentationFormat>A4-Papier (210x297 mm)</PresentationFormat>
  <Paragraphs>44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-Design</vt:lpstr>
      <vt:lpstr>PowerPoint-Präsentation</vt:lpstr>
      <vt:lpstr>PowerPoint-Prä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nke</dc:creator>
  <cp:lastModifiedBy>Wolfram Weckwerth</cp:lastModifiedBy>
  <cp:revision>16</cp:revision>
  <cp:lastPrinted>2013-07-30T12:33:09Z</cp:lastPrinted>
  <dcterms:created xsi:type="dcterms:W3CDTF">2013-04-23T10:17:48Z</dcterms:created>
  <dcterms:modified xsi:type="dcterms:W3CDTF">2013-11-09T17:37:51Z</dcterms:modified>
</cp:coreProperties>
</file>